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601200" cy="12801600" type="A3"/>
  <p:notesSz cx="6858000" cy="9144000"/>
  <p:defaultTextStyle>
    <a:defPPr>
      <a:defRPr lang="en-US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032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1290" y="78"/>
      </p:cViewPr>
      <p:guideLst>
        <p:guide orient="horz" pos="4032"/>
        <p:guide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D7F65C-89DF-4384-86EC-3F89C75985C3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2B5FEC-E4BD-46A8-8938-0C9E9FBA086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19498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3976794"/>
            <a:ext cx="8161020" cy="274404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09248" y="957158"/>
            <a:ext cx="2268616" cy="203877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3397" y="957158"/>
            <a:ext cx="6645831" cy="203877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429" y="5425865"/>
            <a:ext cx="8161020" cy="280034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3397" y="5576993"/>
            <a:ext cx="4457224" cy="1576789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20640" y="5576993"/>
            <a:ext cx="4457224" cy="1576789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865544"/>
            <a:ext cx="4242197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0060" y="4059766"/>
            <a:ext cx="4242197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77277" y="2865544"/>
            <a:ext cx="4243864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77277" y="4059766"/>
            <a:ext cx="4243864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060" y="509693"/>
            <a:ext cx="3158729" cy="216916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53802" y="509694"/>
            <a:ext cx="5367338" cy="10925811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0060" y="2678854"/>
            <a:ext cx="3158729" cy="8756651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1902" y="8961120"/>
            <a:ext cx="5760720" cy="105791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881902" y="1143847"/>
            <a:ext cx="5760720" cy="768096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1902" y="10019031"/>
            <a:ext cx="5760720" cy="1502409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987041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00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0410" y="11865187"/>
            <a:ext cx="30403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808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Overlapgram_Res_Sens.svg.png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656076" y="1763712"/>
            <a:ext cx="8426320" cy="8447088"/>
          </a:xfrm>
        </p:spPr>
      </p:pic>
      <p:sp>
        <p:nvSpPr>
          <p:cNvPr id="5" name="TextBox 4"/>
          <p:cNvSpPr txBox="1"/>
          <p:nvPr/>
        </p:nvSpPr>
        <p:spPr>
          <a:xfrm>
            <a:off x="1" y="0"/>
            <a:ext cx="594359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ry Figure 5. 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187799" y="1346208"/>
            <a:ext cx="11224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Sensitive</a:t>
            </a:r>
            <a:endParaRPr 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971800" y="10820400"/>
            <a:ext cx="4111397" cy="1221091"/>
            <a:chOff x="224356" y="1280833"/>
            <a:chExt cx="4111397" cy="1221091"/>
          </a:xfrm>
        </p:grpSpPr>
        <p:grpSp>
          <p:nvGrpSpPr>
            <p:cNvPr id="8" name="Group 7"/>
            <p:cNvGrpSpPr/>
            <p:nvPr/>
          </p:nvGrpSpPr>
          <p:grpSpPr>
            <a:xfrm rot="5400000">
              <a:off x="-188403" y="1770067"/>
              <a:ext cx="1085003" cy="259485"/>
              <a:chOff x="4035397" y="12176355"/>
              <a:chExt cx="1085003" cy="259485"/>
            </a:xfrm>
          </p:grpSpPr>
          <p:sp>
            <p:nvSpPr>
              <p:cNvPr id="13" name="Rectangle 12"/>
              <p:cNvSpPr>
                <a:spLocks noChangeAspect="1"/>
              </p:cNvSpPr>
              <p:nvPr/>
            </p:nvSpPr>
            <p:spPr>
              <a:xfrm>
                <a:off x="4035397" y="12176355"/>
                <a:ext cx="259485" cy="259485"/>
              </a:xfrm>
              <a:prstGeom prst="rect">
                <a:avLst/>
              </a:prstGeom>
              <a:solidFill>
                <a:srgbClr val="022E61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/>
              <p:cNvSpPr>
                <a:spLocks noChangeAspect="1"/>
              </p:cNvSpPr>
              <p:nvPr/>
            </p:nvSpPr>
            <p:spPr>
              <a:xfrm>
                <a:off x="4466610" y="12191996"/>
                <a:ext cx="243840" cy="24384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angle 14"/>
              <p:cNvSpPr>
                <a:spLocks noChangeAspect="1"/>
              </p:cNvSpPr>
              <p:nvPr/>
            </p:nvSpPr>
            <p:spPr>
              <a:xfrm>
                <a:off x="4876560" y="12191997"/>
                <a:ext cx="243840" cy="243840"/>
              </a:xfrm>
              <a:prstGeom prst="rect">
                <a:avLst/>
              </a:prstGeom>
              <a:solidFill>
                <a:srgbClr val="66001D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510944" y="1725340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 smtClean="0">
                  <a:latin typeface="Times New Roman" pitchFamily="18" charset="0"/>
                  <a:cs typeface="Times New Roman" pitchFamily="18" charset="0"/>
                </a:rPr>
                <a:t>Random Overlap </a:t>
              </a:r>
              <a:endParaRPr lang="en-US" sz="1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00857" y="1280833"/>
              <a:ext cx="37194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 smtClean="0">
                  <a:latin typeface="Times New Roman" pitchFamily="18" charset="0"/>
                  <a:cs typeface="Times New Roman" pitchFamily="18" charset="0"/>
                </a:rPr>
                <a:t>Over-represented non-random overlap</a:t>
              </a:r>
              <a:endParaRPr lang="en-US" sz="1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00857" y="2132592"/>
              <a:ext cx="38348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 smtClean="0">
                  <a:latin typeface="Times New Roman" pitchFamily="18" charset="0"/>
                  <a:cs typeface="Times New Roman" pitchFamily="18" charset="0"/>
                </a:rPr>
                <a:t>Under-represented non-random overlap</a:t>
              </a:r>
              <a:endParaRPr lang="en-US" sz="1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 rot="16200000">
            <a:off x="-228181" y="5787201"/>
            <a:ext cx="11224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Resistant</a:t>
            </a:r>
            <a:endParaRPr 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4"/>
          <p:cNvSpPr txBox="1"/>
          <p:nvPr/>
        </p:nvSpPr>
        <p:spPr>
          <a:xfrm>
            <a:off x="990601" y="890826"/>
            <a:ext cx="7924799" cy="40011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Overlap 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gene-sets </a:t>
            </a:r>
            <a:r>
              <a:rPr lang="en-US" sz="2000" smtClean="0">
                <a:latin typeface="Times New Roman" pitchFamily="18" charset="0"/>
                <a:cs typeface="Times New Roman" pitchFamily="18" charset="0"/>
              </a:rPr>
              <a:t>between 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2000" smtClean="0">
                <a:latin typeface="Times New Roman" pitchFamily="18" charset="0"/>
                <a:cs typeface="Times New Roman" pitchFamily="18" charset="0"/>
              </a:rPr>
              <a:t>rug 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Sensitivity 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2000" smtClean="0">
                <a:latin typeface="Times New Roman" pitchFamily="18" charset="0"/>
                <a:cs typeface="Times New Roman" pitchFamily="18" charset="0"/>
              </a:rPr>
              <a:t>Resistant </a:t>
            </a:r>
            <a:r>
              <a:rPr lang="en-US" sz="2000" smtClean="0">
                <a:latin typeface="Times New Roman" pitchFamily="18" charset="0"/>
                <a:cs typeface="Times New Roman" pitchFamily="18" charset="0"/>
              </a:rPr>
              <a:t>states</a:t>
            </a:r>
            <a:endParaRPr lang="en-US" sz="2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8</TotalTime>
  <Words>23</Words>
  <Application>Microsoft Office PowerPoint</Application>
  <PresentationFormat>A3 Paper (297x420 mm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vougas</dc:creator>
  <cp:lastModifiedBy>kvougas</cp:lastModifiedBy>
  <cp:revision>21</cp:revision>
  <dcterms:created xsi:type="dcterms:W3CDTF">2017-03-09T18:16:21Z</dcterms:created>
  <dcterms:modified xsi:type="dcterms:W3CDTF">2017-04-04T16:15:59Z</dcterms:modified>
</cp:coreProperties>
</file>